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7010400" cy="9296400"/>
  <p:defaultTextStyle>
    <a:defPPr>
      <a:defRPr lang="es-ES_trad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994" autoAdjust="0"/>
  </p:normalViewPr>
  <p:slideViewPr>
    <p:cSldViewPr>
      <p:cViewPr>
        <p:scale>
          <a:sx n="90" d="100"/>
          <a:sy n="90" d="100"/>
        </p:scale>
        <p:origin x="-2340" y="-54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36F596C7-84B9-4329-AC3C-D512F9C11199}" type="datetimeFigureOut">
              <a:rPr lang="es-ES_tradnl" smtClean="0"/>
              <a:pPr/>
              <a:t>25/02/2016</a:t>
            </a:fld>
            <a:endParaRPr lang="es-ES_tradnl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s-ES_tradnl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_tradnl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AA1E12D6-D775-4BB4-8E94-82FBD331AA12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="" xmlns:p14="http://schemas.microsoft.com/office/powerpoint/2010/main" val="34650351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s-ES_tradnl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A1E12D6-D775-4BB4-8E94-82FBD331AA12}" type="slidenum">
              <a:rPr lang="es-ES_tradnl" smtClean="0"/>
              <a:pPr/>
              <a:t>1</a:t>
            </a:fld>
            <a:endParaRPr lang="es-ES_tradnl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_tradnl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170E4-8F2F-4A3A-9943-6F457F0A9549}" type="datetimeFigureOut">
              <a:rPr lang="es-ES_tradnl" smtClean="0"/>
              <a:pPr/>
              <a:t>25/02/2016</a:t>
            </a:fld>
            <a:endParaRPr lang="es-ES_tradn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225BE-298F-430B-BB85-3DCB017C35C8}" type="slidenum">
              <a:rPr lang="es-ES_tradnl" smtClean="0"/>
              <a:pPr/>
              <a:t>‹Nº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_tradnl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170E4-8F2F-4A3A-9943-6F457F0A9549}" type="datetimeFigureOut">
              <a:rPr lang="es-ES_tradnl" smtClean="0"/>
              <a:pPr/>
              <a:t>25/02/2016</a:t>
            </a:fld>
            <a:endParaRPr lang="es-ES_tradn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225BE-298F-430B-BB85-3DCB017C35C8}" type="slidenum">
              <a:rPr lang="es-ES_tradnl" smtClean="0"/>
              <a:pPr/>
              <a:t>‹Nº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_tradnl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170E4-8F2F-4A3A-9943-6F457F0A9549}" type="datetimeFigureOut">
              <a:rPr lang="es-ES_tradnl" smtClean="0"/>
              <a:pPr/>
              <a:t>25/02/2016</a:t>
            </a:fld>
            <a:endParaRPr lang="es-ES_tradn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225BE-298F-430B-BB85-3DCB017C35C8}" type="slidenum">
              <a:rPr lang="es-ES_tradnl" smtClean="0"/>
              <a:pPr/>
              <a:t>‹Nº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_tradnl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170E4-8F2F-4A3A-9943-6F457F0A9549}" type="datetimeFigureOut">
              <a:rPr lang="es-ES_tradnl" smtClean="0"/>
              <a:pPr/>
              <a:t>25/02/2016</a:t>
            </a:fld>
            <a:endParaRPr lang="es-ES_tradn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225BE-298F-430B-BB85-3DCB017C35C8}" type="slidenum">
              <a:rPr lang="es-ES_tradnl" smtClean="0"/>
              <a:pPr/>
              <a:t>‹Nº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170E4-8F2F-4A3A-9943-6F457F0A9549}" type="datetimeFigureOut">
              <a:rPr lang="es-ES_tradnl" smtClean="0"/>
              <a:pPr/>
              <a:t>25/02/2016</a:t>
            </a:fld>
            <a:endParaRPr lang="es-ES_tradn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225BE-298F-430B-BB85-3DCB017C35C8}" type="slidenum">
              <a:rPr lang="es-ES_tradnl" smtClean="0"/>
              <a:pPr/>
              <a:t>‹Nº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_tradnl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_tradnl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170E4-8F2F-4A3A-9943-6F457F0A9549}" type="datetimeFigureOut">
              <a:rPr lang="es-ES_tradnl" smtClean="0"/>
              <a:pPr/>
              <a:t>25/02/2016</a:t>
            </a:fld>
            <a:endParaRPr lang="es-ES_tradnl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225BE-298F-430B-BB85-3DCB017C35C8}" type="slidenum">
              <a:rPr lang="es-ES_tradnl" smtClean="0"/>
              <a:pPr/>
              <a:t>‹Nº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_tradnl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_tradnl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170E4-8F2F-4A3A-9943-6F457F0A9549}" type="datetimeFigureOut">
              <a:rPr lang="es-ES_tradnl" smtClean="0"/>
              <a:pPr/>
              <a:t>25/02/2016</a:t>
            </a:fld>
            <a:endParaRPr lang="es-ES_tradnl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225BE-298F-430B-BB85-3DCB017C35C8}" type="slidenum">
              <a:rPr lang="es-ES_tradnl" smtClean="0"/>
              <a:pPr/>
              <a:t>‹Nº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170E4-8F2F-4A3A-9943-6F457F0A9549}" type="datetimeFigureOut">
              <a:rPr lang="es-ES_tradnl" smtClean="0"/>
              <a:pPr/>
              <a:t>25/02/2016</a:t>
            </a:fld>
            <a:endParaRPr lang="es-ES_tradnl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225BE-298F-430B-BB85-3DCB017C35C8}" type="slidenum">
              <a:rPr lang="es-ES_tradnl" smtClean="0"/>
              <a:pPr/>
              <a:t>‹Nº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170E4-8F2F-4A3A-9943-6F457F0A9549}" type="datetimeFigureOut">
              <a:rPr lang="es-ES_tradnl" smtClean="0"/>
              <a:pPr/>
              <a:t>25/02/2016</a:t>
            </a:fld>
            <a:endParaRPr lang="es-ES_tradnl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225BE-298F-430B-BB85-3DCB017C35C8}" type="slidenum">
              <a:rPr lang="es-ES_tradnl" smtClean="0"/>
              <a:pPr/>
              <a:t>‹Nº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_tradnl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170E4-8F2F-4A3A-9943-6F457F0A9549}" type="datetimeFigureOut">
              <a:rPr lang="es-ES_tradnl" smtClean="0"/>
              <a:pPr/>
              <a:t>25/02/2016</a:t>
            </a:fld>
            <a:endParaRPr lang="es-ES_tradnl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225BE-298F-430B-BB85-3DCB017C35C8}" type="slidenum">
              <a:rPr lang="es-ES_tradnl" smtClean="0"/>
              <a:pPr/>
              <a:t>‹Nº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_tradnl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170E4-8F2F-4A3A-9943-6F457F0A9549}" type="datetimeFigureOut">
              <a:rPr lang="es-ES_tradnl" smtClean="0"/>
              <a:pPr/>
              <a:t>25/02/2016</a:t>
            </a:fld>
            <a:endParaRPr lang="es-ES_tradnl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225BE-298F-430B-BB85-3DCB017C35C8}" type="slidenum">
              <a:rPr lang="es-ES_tradnl" smtClean="0"/>
              <a:pPr/>
              <a:t>‹Nº›</a:t>
            </a:fld>
            <a:endParaRPr lang="es-ES_tradn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_tradnl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_tradnl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9170E4-8F2F-4A3A-9943-6F457F0A9549}" type="datetimeFigureOut">
              <a:rPr lang="es-ES_tradnl" smtClean="0"/>
              <a:pPr/>
              <a:t>25/02/2016</a:t>
            </a:fld>
            <a:endParaRPr lang="es-ES_tradnl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_tradnl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0225BE-298F-430B-BB85-3DCB017C35C8}" type="slidenum">
              <a:rPr lang="es-ES_tradnl" smtClean="0"/>
              <a:pPr/>
              <a:t>‹Nº›</a:t>
            </a:fld>
            <a:endParaRPr lang="es-ES_tradn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_trad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/>
          <p:cNvSpPr txBox="1"/>
          <p:nvPr/>
        </p:nvSpPr>
        <p:spPr>
          <a:xfrm>
            <a:off x="755576" y="332656"/>
            <a:ext cx="777686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smtClean="0"/>
              <a:t>S1 </a:t>
            </a:r>
            <a:r>
              <a:rPr lang="en-US" b="1" smtClean="0"/>
              <a:t>Fig. </a:t>
            </a:r>
            <a:r>
              <a:rPr lang="en-US" b="1" dirty="0" smtClean="0"/>
              <a:t>Decay of NADH concentration in the BCAT activity assay</a:t>
            </a:r>
            <a:r>
              <a:rPr lang="en-US" dirty="0" smtClean="0"/>
              <a:t>. One of the replicates of the experiment is shown. (A) CM. (B) HIFBS-depletion.</a:t>
            </a:r>
            <a:endParaRPr lang="en-US" dirty="0"/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17207" y="1157493"/>
            <a:ext cx="4254993" cy="53678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34</Words>
  <Application>Microsoft Office PowerPoint</Application>
  <PresentationFormat>Presentación en pantalla (4:3)</PresentationFormat>
  <Paragraphs>2</Paragraphs>
  <Slides>1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Pedro</dc:creator>
  <cp:lastModifiedBy>Propietario</cp:lastModifiedBy>
  <cp:revision>10</cp:revision>
  <cp:lastPrinted>2013-07-24T04:12:04Z</cp:lastPrinted>
  <dcterms:created xsi:type="dcterms:W3CDTF">2013-07-23T06:30:59Z</dcterms:created>
  <dcterms:modified xsi:type="dcterms:W3CDTF">2016-02-25T12:06:38Z</dcterms:modified>
</cp:coreProperties>
</file>